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61" r:id="rId1"/>
  </p:sldMasterIdLst>
  <p:notesMasterIdLst>
    <p:notesMasterId r:id="rId3"/>
  </p:notesMasterIdLst>
  <p:sldIdLst>
    <p:sldId id="269" r:id="rId2"/>
  </p:sldIdLst>
  <p:sldSz cx="12192000" cy="6858000"/>
  <p:notesSz cx="7559675" cy="10691813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4" roundtripDataSignature="AMtx7mjLtWvgeW2kJZtJm7N1ip0vzcJK7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4C87017E-015C-41D7-BCCA-D7CF521AE421}">
  <a:tblStyle styleId="{4C87017E-015C-41D7-BCCA-D7CF521AE421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Designformatvorlage 1 - Akz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4943" autoAdjust="0"/>
  </p:normalViewPr>
  <p:slideViewPr>
    <p:cSldViewPr snapToGrid="0">
      <p:cViewPr varScale="1">
        <p:scale>
          <a:sx n="104" d="100"/>
          <a:sy n="104" d="100"/>
        </p:scale>
        <p:origin x="176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15" Type="http://schemas.openxmlformats.org/officeDocument/2006/relationships/presProps" Target="presProps.xml"/><Relationship Id="rId14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260175" y="801875"/>
            <a:ext cx="5040025" cy="40094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755950" y="5078600"/>
            <a:ext cx="6047725" cy="4811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x">
  <p:cSld name="TITLE_AND_BODY"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26"/>
          <p:cNvSpPr txBox="1"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8" name="Google Shape;68;p26"/>
          <p:cNvSpPr txBox="1">
            <a:spLocks noGrp="1"/>
          </p:cNvSpPr>
          <p:nvPr>
            <p:ph type="subTitle" idx="1"/>
          </p:nvPr>
        </p:nvSpPr>
        <p:spPr>
          <a:xfrm>
            <a:off x="838080" y="1825560"/>
            <a:ext cx="10515240" cy="4350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6 Content">
  <p:cSld name="Title, 6 Content"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36"/>
          <p:cNvSpPr txBox="1"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7" name="Google Shape;107;p36"/>
          <p:cNvSpPr txBox="1">
            <a:spLocks noGrp="1"/>
          </p:cNvSpPr>
          <p:nvPr>
            <p:ph type="body" idx="1"/>
          </p:nvPr>
        </p:nvSpPr>
        <p:spPr>
          <a:xfrm>
            <a:off x="838080" y="1825560"/>
            <a:ext cx="338580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8" name="Google Shape;108;p36"/>
          <p:cNvSpPr txBox="1">
            <a:spLocks noGrp="1"/>
          </p:cNvSpPr>
          <p:nvPr>
            <p:ph type="body" idx="2"/>
          </p:nvPr>
        </p:nvSpPr>
        <p:spPr>
          <a:xfrm>
            <a:off x="4393440" y="1825560"/>
            <a:ext cx="338580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9" name="Google Shape;109;p36"/>
          <p:cNvSpPr txBox="1">
            <a:spLocks noGrp="1"/>
          </p:cNvSpPr>
          <p:nvPr>
            <p:ph type="body" idx="3"/>
          </p:nvPr>
        </p:nvSpPr>
        <p:spPr>
          <a:xfrm>
            <a:off x="7949160" y="1825560"/>
            <a:ext cx="338580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0" name="Google Shape;110;p36"/>
          <p:cNvSpPr txBox="1">
            <a:spLocks noGrp="1"/>
          </p:cNvSpPr>
          <p:nvPr>
            <p:ph type="body" idx="4"/>
          </p:nvPr>
        </p:nvSpPr>
        <p:spPr>
          <a:xfrm>
            <a:off x="838080" y="4098240"/>
            <a:ext cx="338580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1" name="Google Shape;111;p36"/>
          <p:cNvSpPr txBox="1">
            <a:spLocks noGrp="1"/>
          </p:cNvSpPr>
          <p:nvPr>
            <p:ph type="body" idx="5"/>
          </p:nvPr>
        </p:nvSpPr>
        <p:spPr>
          <a:xfrm>
            <a:off x="4393440" y="4098240"/>
            <a:ext cx="338580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2" name="Google Shape;112;p36"/>
          <p:cNvSpPr txBox="1">
            <a:spLocks noGrp="1"/>
          </p:cNvSpPr>
          <p:nvPr>
            <p:ph type="body" idx="6"/>
          </p:nvPr>
        </p:nvSpPr>
        <p:spPr>
          <a:xfrm>
            <a:off x="7949160" y="4098240"/>
            <a:ext cx="338580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" type="twoObj">
  <p:cSld name="TWO_OBJECTS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8"/>
          <p:cNvSpPr txBox="1"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8"/>
          <p:cNvSpPr txBox="1">
            <a:spLocks noGrp="1"/>
          </p:cNvSpPr>
          <p:nvPr>
            <p:ph type="body" idx="1"/>
          </p:nvPr>
        </p:nvSpPr>
        <p:spPr>
          <a:xfrm>
            <a:off x="838080" y="1825560"/>
            <a:ext cx="5131080" cy="4350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5" name="Google Shape;75;p28"/>
          <p:cNvSpPr txBox="1">
            <a:spLocks noGrp="1"/>
          </p:cNvSpPr>
          <p:nvPr>
            <p:ph type="body" idx="2"/>
          </p:nvPr>
        </p:nvSpPr>
        <p:spPr>
          <a:xfrm>
            <a:off x="6226200" y="1825560"/>
            <a:ext cx="5131080" cy="4350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29"/>
          <p:cNvSpPr txBox="1"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entered Text" type="objOnly">
  <p:cSld name="OBJECT_ONLY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30"/>
          <p:cNvSpPr txBox="1">
            <a:spLocks noGrp="1"/>
          </p:cNvSpPr>
          <p:nvPr>
            <p:ph type="subTitle" idx="1"/>
          </p:nvPr>
        </p:nvSpPr>
        <p:spPr>
          <a:xfrm>
            <a:off x="838080" y="365040"/>
            <a:ext cx="10515240" cy="61441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and Content" type="twoObjAndObj">
  <p:cSld name="TWO_OBJECTS_AND_OBJECT"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31"/>
          <p:cNvSpPr txBox="1"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31"/>
          <p:cNvSpPr txBox="1">
            <a:spLocks noGrp="1"/>
          </p:cNvSpPr>
          <p:nvPr>
            <p:ph type="body" idx="1"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31"/>
          <p:cNvSpPr txBox="1">
            <a:spLocks noGrp="1"/>
          </p:cNvSpPr>
          <p:nvPr>
            <p:ph type="body" idx="2"/>
          </p:nvPr>
        </p:nvSpPr>
        <p:spPr>
          <a:xfrm>
            <a:off x="6226200" y="1825560"/>
            <a:ext cx="5131080" cy="4350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4" name="Google Shape;84;p31"/>
          <p:cNvSpPr txBox="1">
            <a:spLocks noGrp="1"/>
          </p:cNvSpPr>
          <p:nvPr>
            <p:ph type="body" idx="3"/>
          </p:nvPr>
        </p:nvSpPr>
        <p:spPr>
          <a:xfrm>
            <a:off x="838080" y="409824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Content and 2 Content" type="objAndTwoObj">
  <p:cSld name="OBJECT_AND_TWO_OBJECTS"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32"/>
          <p:cNvSpPr txBox="1"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7" name="Google Shape;87;p32"/>
          <p:cNvSpPr txBox="1">
            <a:spLocks noGrp="1"/>
          </p:cNvSpPr>
          <p:nvPr>
            <p:ph type="body" idx="1"/>
          </p:nvPr>
        </p:nvSpPr>
        <p:spPr>
          <a:xfrm>
            <a:off x="838080" y="1825560"/>
            <a:ext cx="5131080" cy="4350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8" name="Google Shape;88;p32"/>
          <p:cNvSpPr txBox="1">
            <a:spLocks noGrp="1"/>
          </p:cNvSpPr>
          <p:nvPr>
            <p:ph type="body" idx="2"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9" name="Google Shape;89;p32"/>
          <p:cNvSpPr txBox="1">
            <a:spLocks noGrp="1"/>
          </p:cNvSpPr>
          <p:nvPr>
            <p:ph type="body" idx="3"/>
          </p:nvPr>
        </p:nvSpPr>
        <p:spPr>
          <a:xfrm>
            <a:off x="6226200" y="409824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2 Content over Content" type="twoObjOverTx">
  <p:cSld name="TWO_OBJECTS_OVER_TEXT"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33"/>
          <p:cNvSpPr txBox="1"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2" name="Google Shape;92;p33"/>
          <p:cNvSpPr txBox="1">
            <a:spLocks noGrp="1"/>
          </p:cNvSpPr>
          <p:nvPr>
            <p:ph type="body" idx="1"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3" name="Google Shape;93;p33"/>
          <p:cNvSpPr txBox="1">
            <a:spLocks noGrp="1"/>
          </p:cNvSpPr>
          <p:nvPr>
            <p:ph type="body" idx="2"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4" name="Google Shape;94;p33"/>
          <p:cNvSpPr txBox="1">
            <a:spLocks noGrp="1"/>
          </p:cNvSpPr>
          <p:nvPr>
            <p:ph type="body" idx="3"/>
          </p:nvPr>
        </p:nvSpPr>
        <p:spPr>
          <a:xfrm>
            <a:off x="838080" y="4098240"/>
            <a:ext cx="1051524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 over Content" type="objOverTx">
  <p:cSld name="OBJECT_OVER_TEXT"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34"/>
          <p:cNvSpPr txBox="1"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7" name="Google Shape;97;p34"/>
          <p:cNvSpPr txBox="1">
            <a:spLocks noGrp="1"/>
          </p:cNvSpPr>
          <p:nvPr>
            <p:ph type="body" idx="1"/>
          </p:nvPr>
        </p:nvSpPr>
        <p:spPr>
          <a:xfrm>
            <a:off x="838080" y="1825560"/>
            <a:ext cx="1051524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8" name="Google Shape;98;p34"/>
          <p:cNvSpPr txBox="1">
            <a:spLocks noGrp="1"/>
          </p:cNvSpPr>
          <p:nvPr>
            <p:ph type="body" idx="2"/>
          </p:nvPr>
        </p:nvSpPr>
        <p:spPr>
          <a:xfrm>
            <a:off x="838080" y="4098240"/>
            <a:ext cx="1051524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4 Content" type="fourObj">
  <p:cSld name="FOUR_OBJECTS"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35"/>
          <p:cNvSpPr txBox="1"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1" name="Google Shape;101;p35"/>
          <p:cNvSpPr txBox="1">
            <a:spLocks noGrp="1"/>
          </p:cNvSpPr>
          <p:nvPr>
            <p:ph type="body" idx="1"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2" name="Google Shape;102;p35"/>
          <p:cNvSpPr txBox="1">
            <a:spLocks noGrp="1"/>
          </p:cNvSpPr>
          <p:nvPr>
            <p:ph type="body" idx="2"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3" name="Google Shape;103;p35"/>
          <p:cNvSpPr txBox="1">
            <a:spLocks noGrp="1"/>
          </p:cNvSpPr>
          <p:nvPr>
            <p:ph type="body" idx="3"/>
          </p:nvPr>
        </p:nvSpPr>
        <p:spPr>
          <a:xfrm>
            <a:off x="838080" y="409824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4" name="Google Shape;104;p35"/>
          <p:cNvSpPr txBox="1">
            <a:spLocks noGrp="1"/>
          </p:cNvSpPr>
          <p:nvPr>
            <p:ph type="body" idx="4"/>
          </p:nvPr>
        </p:nvSpPr>
        <p:spPr>
          <a:xfrm>
            <a:off x="6226200" y="4098240"/>
            <a:ext cx="5131080" cy="20750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marL="914400" lvl="1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marL="1371600" lvl="2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marL="1828800" lvl="3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marL="2286000" lvl="4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marL="2743200" lvl="5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marL="3200400" lvl="6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marL="3657600" lvl="7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marL="4114800" lvl="8" indent="-22860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1"/>
          <p:cNvSpPr txBox="1">
            <a:spLocks noGrp="1"/>
          </p:cNvSpPr>
          <p:nvPr>
            <p:ph type="dt" idx="10"/>
          </p:nvPr>
        </p:nvSpPr>
        <p:spPr>
          <a:xfrm>
            <a:off x="838080" y="6356520"/>
            <a:ext cx="2742840" cy="3646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9pPr>
          </a:lstStyle>
          <a:p>
            <a:endParaRPr/>
          </a:p>
        </p:txBody>
      </p:sp>
      <p:sp>
        <p:nvSpPr>
          <p:cNvPr id="61" name="Google Shape;61;p11"/>
          <p:cNvSpPr txBox="1">
            <a:spLocks noGrp="1"/>
          </p:cNvSpPr>
          <p:nvPr>
            <p:ph type="ftr" idx="11"/>
          </p:nvPr>
        </p:nvSpPr>
        <p:spPr>
          <a:xfrm>
            <a:off x="4038480" y="6356520"/>
            <a:ext cx="4114440" cy="3646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9pPr>
          </a:lstStyle>
          <a:p>
            <a:endParaRPr/>
          </a:p>
        </p:txBody>
      </p:sp>
      <p:sp>
        <p:nvSpPr>
          <p:cNvPr id="62" name="Google Shape;62;p11"/>
          <p:cNvSpPr txBox="1">
            <a:spLocks noGrp="1"/>
          </p:cNvSpPr>
          <p:nvPr>
            <p:ph type="sldNum" idx="12"/>
          </p:nvPr>
        </p:nvSpPr>
        <p:spPr>
          <a:xfrm>
            <a:off x="8610480" y="6356520"/>
            <a:ext cx="2742840" cy="3646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buNone/>
              <a:defRPr sz="1200" b="0" i="0" u="none" strike="noStrike" cap="none">
                <a:solidFill>
                  <a:srgbClr val="8B8B8B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buNone/>
              <a:defRPr sz="1200" b="0" i="0" u="none" strike="noStrike" cap="none">
                <a:solidFill>
                  <a:srgbClr val="8B8B8B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buNone/>
              <a:defRPr sz="1200" b="0" i="0" u="none" strike="noStrike" cap="none">
                <a:solidFill>
                  <a:srgbClr val="8B8B8B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buNone/>
              <a:defRPr sz="1200" b="0" i="0" u="none" strike="noStrike" cap="none">
                <a:solidFill>
                  <a:srgbClr val="8B8B8B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buNone/>
              <a:defRPr sz="1200" b="0" i="0" u="none" strike="noStrike" cap="none">
                <a:solidFill>
                  <a:srgbClr val="8B8B8B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buNone/>
              <a:defRPr sz="1200" b="0" i="0" u="none" strike="noStrike" cap="none">
                <a:solidFill>
                  <a:srgbClr val="8B8B8B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buNone/>
              <a:defRPr sz="1200" b="0" i="0" u="none" strike="noStrike" cap="none">
                <a:solidFill>
                  <a:srgbClr val="8B8B8B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buNone/>
              <a:defRPr sz="1200" b="0" i="0" u="none" strike="noStrike" cap="none">
                <a:solidFill>
                  <a:srgbClr val="8B8B8B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buNone/>
              <a:defRPr sz="1200" b="0" i="0" u="none" strike="noStrike" cap="none">
                <a:solidFill>
                  <a:srgbClr val="8B8B8B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63" name="Google Shape;63;p11"/>
          <p:cNvSpPr txBox="1"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9pPr>
          </a:lstStyle>
          <a:p>
            <a:endParaRPr/>
          </a:p>
        </p:txBody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63" r:id="rId1"/>
    <p:sldLayoutId id="2147483665" r:id="rId2"/>
    <p:sldLayoutId id="2147483666" r:id="rId3"/>
    <p:sldLayoutId id="2147483667" r:id="rId4"/>
    <p:sldLayoutId id="2147483668" r:id="rId5"/>
    <p:sldLayoutId id="2147483669" r:id="rId6"/>
    <p:sldLayoutId id="2147483670" r:id="rId7"/>
    <p:sldLayoutId id="2147483671" r:id="rId8"/>
    <p:sldLayoutId id="2147483672" r:id="rId9"/>
    <p:sldLayoutId id="2147483673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3639421"/>
              </p:ext>
            </p:extLst>
          </p:nvPr>
        </p:nvGraphicFramePr>
        <p:xfrm>
          <a:off x="760396" y="375385"/>
          <a:ext cx="10154652" cy="6167802"/>
        </p:xfrm>
        <a:graphic>
          <a:graphicData uri="http://schemas.openxmlformats.org/drawingml/2006/table">
            <a:tbl>
              <a:tblPr firstRow="1" firstCol="1" bandRow="1">
                <a:tableStyleId>{4C87017E-015C-41D7-BCCA-D7CF521AE421}</a:tableStyleId>
              </a:tblPr>
              <a:tblGrid>
                <a:gridCol w="1395663">
                  <a:extLst>
                    <a:ext uri="{9D8B030D-6E8A-4147-A177-3AD203B41FA5}">
                      <a16:colId xmlns:a16="http://schemas.microsoft.com/office/drawing/2014/main" val="2333547971"/>
                    </a:ext>
                  </a:extLst>
                </a:gridCol>
                <a:gridCol w="2589196">
                  <a:extLst>
                    <a:ext uri="{9D8B030D-6E8A-4147-A177-3AD203B41FA5}">
                      <a16:colId xmlns:a16="http://schemas.microsoft.com/office/drawing/2014/main" val="551527978"/>
                    </a:ext>
                  </a:extLst>
                </a:gridCol>
                <a:gridCol w="1337911">
                  <a:extLst>
                    <a:ext uri="{9D8B030D-6E8A-4147-A177-3AD203B41FA5}">
                      <a16:colId xmlns:a16="http://schemas.microsoft.com/office/drawing/2014/main" val="2650894165"/>
                    </a:ext>
                  </a:extLst>
                </a:gridCol>
                <a:gridCol w="789272">
                  <a:extLst>
                    <a:ext uri="{9D8B030D-6E8A-4147-A177-3AD203B41FA5}">
                      <a16:colId xmlns:a16="http://schemas.microsoft.com/office/drawing/2014/main" val="1241149074"/>
                    </a:ext>
                  </a:extLst>
                </a:gridCol>
                <a:gridCol w="616017">
                  <a:extLst>
                    <a:ext uri="{9D8B030D-6E8A-4147-A177-3AD203B41FA5}">
                      <a16:colId xmlns:a16="http://schemas.microsoft.com/office/drawing/2014/main" val="3687993124"/>
                    </a:ext>
                  </a:extLst>
                </a:gridCol>
                <a:gridCol w="856648">
                  <a:extLst>
                    <a:ext uri="{9D8B030D-6E8A-4147-A177-3AD203B41FA5}">
                      <a16:colId xmlns:a16="http://schemas.microsoft.com/office/drawing/2014/main" val="219976020"/>
                    </a:ext>
                  </a:extLst>
                </a:gridCol>
                <a:gridCol w="827773">
                  <a:extLst>
                    <a:ext uri="{9D8B030D-6E8A-4147-A177-3AD203B41FA5}">
                      <a16:colId xmlns:a16="http://schemas.microsoft.com/office/drawing/2014/main" val="3029822961"/>
                    </a:ext>
                  </a:extLst>
                </a:gridCol>
                <a:gridCol w="750770">
                  <a:extLst>
                    <a:ext uri="{9D8B030D-6E8A-4147-A177-3AD203B41FA5}">
                      <a16:colId xmlns:a16="http://schemas.microsoft.com/office/drawing/2014/main" val="1742653179"/>
                    </a:ext>
                  </a:extLst>
                </a:gridCol>
                <a:gridCol w="991402">
                  <a:extLst>
                    <a:ext uri="{9D8B030D-6E8A-4147-A177-3AD203B41FA5}">
                      <a16:colId xmlns:a16="http://schemas.microsoft.com/office/drawing/2014/main" val="541868996"/>
                    </a:ext>
                  </a:extLst>
                </a:gridCol>
              </a:tblGrid>
              <a:tr h="388275">
                <a:tc gridSpan="9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1200" b="1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Arial"/>
                          <a:cs typeface="Arial"/>
                          <a:sym typeface="Arial"/>
                        </a:rPr>
                        <a:t>Supplement</a:t>
                      </a:r>
                      <a:r>
                        <a:rPr lang="de-CH" sz="1200" b="1" i="0" u="none" strike="noStrike" cap="non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Arial"/>
                          <a:cs typeface="Arial"/>
                          <a:sym typeface="Arial"/>
                        </a:rPr>
                        <a:t> </a:t>
                      </a:r>
                      <a:r>
                        <a:rPr lang="de-CH" sz="1200" b="1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: </a:t>
                      </a:r>
                      <a:r>
                        <a:rPr lang="en-US" sz="1200" b="1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utcome-based nursing assessment for acute care (ePA-AC) - items by category with relevance for risk assessments. </a:t>
                      </a:r>
                      <a:endParaRPr lang="de-CH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L w="12700" cmpd="sng">
                      <a:noFill/>
                      <a:prstDash val="soli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vert="vert27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vert="vert27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vert="vert27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vert="vert27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vert="vert27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vert="vert270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vert="vert270">
                    <a:lnL w="12700" cmpd="sng">
                      <a:noFill/>
                      <a:prstDash val="soli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23769678"/>
                  </a:ext>
                </a:extLst>
              </a:tr>
              <a:tr h="3728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 smtClean="0">
                          <a:effectLst/>
                        </a:rPr>
                        <a:t>Category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Items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 err="1" smtClean="0">
                          <a:effectLst/>
                        </a:rPr>
                        <a:t>Self</a:t>
                      </a:r>
                      <a:r>
                        <a:rPr lang="de-CH" sz="800" dirty="0" smtClean="0">
                          <a:effectLst/>
                        </a:rPr>
                        <a:t>-care </a:t>
                      </a:r>
                      <a:r>
                        <a:rPr lang="de-CH" sz="800" dirty="0" err="1" smtClean="0">
                          <a:effectLst/>
                        </a:rPr>
                        <a:t>index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Arial"/>
                          <a:cs typeface="Arial"/>
                          <a:sym typeface="Arial"/>
                        </a:rPr>
                        <a:t>Braden score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 err="1" smtClean="0">
                          <a:effectLst/>
                        </a:rPr>
                        <a:t>Risk</a:t>
                      </a:r>
                      <a:r>
                        <a:rPr lang="de-CH" sz="800" dirty="0" smtClean="0">
                          <a:effectLst/>
                        </a:rPr>
                        <a:t> of </a:t>
                      </a:r>
                      <a:r>
                        <a:rPr lang="de-CH" sz="800" dirty="0" err="1" smtClean="0">
                          <a:effectLst/>
                        </a:rPr>
                        <a:t>falling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Arial"/>
                          <a:cs typeface="Arial"/>
                          <a:sym typeface="Arial"/>
                        </a:rPr>
                        <a:t>Pneumonia risk 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Arial"/>
                          <a:cs typeface="Arial"/>
                          <a:sym typeface="Arial"/>
                        </a:rPr>
                        <a:t>Confusion/</a:t>
                      </a:r>
                    </a:p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Arial"/>
                          <a:cs typeface="Arial"/>
                          <a:sym typeface="Arial"/>
                        </a:rPr>
                        <a:t>delirium/</a:t>
                      </a:r>
                    </a:p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Arial"/>
                          <a:cs typeface="Arial"/>
                          <a:sym typeface="Arial"/>
                        </a:rPr>
                        <a:t>dementia 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Arial"/>
                          <a:cs typeface="Arial"/>
                          <a:sym typeface="Arial"/>
                        </a:rPr>
                        <a:t>Food quantity (total)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71755" marR="7175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 smtClean="0">
                          <a:effectLst/>
                        </a:rPr>
                        <a:t>Malnutrition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101704962"/>
                  </a:ext>
                </a:extLst>
              </a:tr>
              <a:tr h="210701">
                <a:tc rowSpan="8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 smtClean="0">
                          <a:effectLst/>
                        </a:rPr>
                        <a:t>Movement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F Activity/continuous movemen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2222290427"/>
                  </a:ext>
                </a:extLst>
              </a:tr>
              <a:tr h="28267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lf-care ability Mobility/change of body positio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X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1395167034"/>
                  </a:ext>
                </a:extLst>
              </a:tr>
              <a:tr h="28267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riction/shear forces during change of position/transfe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1389521628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tered gait patter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70213104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lance disturbanc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242104571"/>
                  </a:ext>
                </a:extLst>
              </a:tr>
              <a:tr h="2107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ll event in the last two month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2237985918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urrent</a:t>
                      </a:r>
                      <a:r>
                        <a:rPr lang="de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fall </a:t>
                      </a:r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vent</a:t>
                      </a:r>
                      <a:endParaRPr lang="de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2697874997"/>
                  </a:ext>
                </a:extLst>
              </a:tr>
              <a:tr h="13457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igue</a:t>
                      </a:r>
                      <a:r>
                        <a:rPr lang="de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</a:t>
                      </a:r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xhaustion</a:t>
                      </a:r>
                      <a:endParaRPr lang="de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619760054"/>
                  </a:ext>
                </a:extLst>
              </a:tr>
              <a:tr h="138728">
                <a:tc row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 smtClean="0">
                          <a:effectLst/>
                        </a:rPr>
                        <a:t>Personal </a:t>
                      </a:r>
                      <a:r>
                        <a:rPr lang="de-CH" sz="800" dirty="0" err="1" smtClean="0">
                          <a:effectLst/>
                        </a:rPr>
                        <a:t>hygiene</a:t>
                      </a:r>
                      <a:r>
                        <a:rPr lang="de-CH" sz="800" dirty="0" smtClean="0">
                          <a:effectLst/>
                        </a:rPr>
                        <a:t> and </a:t>
                      </a:r>
                      <a:r>
                        <a:rPr lang="de-CH" sz="800" dirty="0" err="1" smtClean="0">
                          <a:effectLst/>
                        </a:rPr>
                        <a:t>dressing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F Body Care Upper Bod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845234477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F Body Care Lower Bod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2529488282"/>
                  </a:ext>
                </a:extLst>
              </a:tr>
              <a:tr h="2107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F dressing/undressing upper bod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500900533"/>
                  </a:ext>
                </a:extLst>
              </a:tr>
              <a:tr h="2107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F dressing/undressing lower bod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1437229301"/>
                  </a:ext>
                </a:extLst>
              </a:tr>
              <a:tr h="130391">
                <a:tc rowSpan="1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 smtClean="0">
                          <a:effectLst/>
                          <a:latin typeface="Arial"/>
                          <a:ea typeface="Calibri" panose="020F0502020204030204" pitchFamily="34" charset="0"/>
                          <a:cs typeface="Arial"/>
                        </a:rPr>
                        <a:t>Nutrition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F Foo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3935280126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ount of food (oral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4094918082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ergy</a:t>
                      </a:r>
                      <a:r>
                        <a:rPr lang="de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</a:t>
                      </a:r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trient</a:t>
                      </a:r>
                      <a:r>
                        <a:rPr lang="de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quirements</a:t>
                      </a:r>
                      <a:endParaRPr lang="de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1903792985"/>
                  </a:ext>
                </a:extLst>
              </a:tr>
              <a:tr h="2107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tificial nutrition/prescribed supplemental foo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2223534975"/>
                  </a:ext>
                </a:extLst>
              </a:tr>
              <a:tr h="1303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F Drinkin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X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637175404"/>
                  </a:ext>
                </a:extLst>
              </a:tr>
              <a:tr h="1303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rinking amoun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1336556082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id supplementatio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3693389533"/>
                  </a:ext>
                </a:extLst>
              </a:tr>
              <a:tr h="1303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id requirement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1167666927"/>
                  </a:ext>
                </a:extLst>
              </a:tr>
              <a:tr h="1303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ube feedin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1196196618"/>
                  </a:ext>
                </a:extLst>
              </a:tr>
              <a:tr h="1303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ysphagi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3478658889"/>
                  </a:ext>
                </a:extLst>
              </a:tr>
              <a:tr h="1303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use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374268634"/>
                  </a:ext>
                </a:extLst>
              </a:tr>
              <a:tr h="138728">
                <a:tc rowSpan="8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 err="1" smtClean="0">
                          <a:effectLst/>
                        </a:rPr>
                        <a:t>Excretion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F Urinary outpu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X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204113837"/>
                  </a:ext>
                </a:extLst>
              </a:tr>
              <a:tr h="2107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ility to control urine outpu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743944892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F Fecal excretio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1960383360"/>
                  </a:ext>
                </a:extLst>
              </a:tr>
              <a:tr h="2107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ility to control excretion of stoo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3611855412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rge/increased excretio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X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3682317136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rinary diversion syste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2077761073"/>
                  </a:ext>
                </a:extLst>
              </a:tr>
              <a:tr h="1387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cal</a:t>
                      </a:r>
                      <a:r>
                        <a:rPr lang="de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limination</a:t>
                      </a:r>
                      <a:r>
                        <a:rPr lang="de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ystem</a:t>
                      </a:r>
                      <a:endParaRPr lang="de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>
                          <a:effectLst/>
                        </a:rPr>
                        <a:t> </a:t>
                      </a:r>
                      <a:endParaRPr lang="de-CH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/>
                </a:tc>
                <a:extLst>
                  <a:ext uri="{0D108BD9-81ED-4DB2-BD59-A6C34878D82A}">
                    <a16:rowId xmlns:a16="http://schemas.microsoft.com/office/drawing/2014/main" val="3226452427"/>
                  </a:ext>
                </a:extLst>
              </a:tr>
              <a:tr h="1303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in </a:t>
                      </a:r>
                      <a:r>
                        <a:rPr lang="de-CH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isture</a:t>
                      </a:r>
                      <a:endParaRPr lang="de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X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>
                          <a:effectLst/>
                        </a:rPr>
                        <a:t> </a:t>
                      </a:r>
                      <a:endParaRPr lang="de-CH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359" marR="3235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979789"/>
                  </a:ext>
                </a:extLst>
              </a:tr>
              <a:tr h="35838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CH" sz="800" dirty="0" smtClean="0">
                          <a:effectLst/>
                        </a:rPr>
                        <a:t>X =</a:t>
                      </a:r>
                      <a:r>
                        <a:rPr lang="de-CH" sz="800" baseline="0" dirty="0" smtClean="0">
                          <a:effectLst/>
                        </a:rPr>
                        <a:t> </a:t>
                      </a:r>
                      <a:r>
                        <a:rPr lang="en-US" sz="800" baseline="0" dirty="0" smtClean="0">
                          <a:effectLst/>
                        </a:rPr>
                        <a:t>exemplary scoring as an illustration</a:t>
                      </a:r>
                      <a:endParaRPr lang="de-CH" sz="800" dirty="0">
                        <a:effectLst/>
                      </a:endParaRPr>
                    </a:p>
                  </a:txBody>
                  <a:tcPr marL="52424" marR="52424" marT="0" marB="0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4" marR="5242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4" marR="5242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4" marR="5242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4" marR="5242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4" marR="5242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4" marR="5242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CH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424" marR="5242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828264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39331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7</Words>
  <Application>Microsoft Office PowerPoint</Application>
  <PresentationFormat>Breitbild</PresentationFormat>
  <Paragraphs>26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lvachizadeh Sascha</dc:creator>
  <cp:lastModifiedBy>Berk Till</cp:lastModifiedBy>
  <cp:revision>152</cp:revision>
  <dcterms:created xsi:type="dcterms:W3CDTF">2020-01-15T10:05:29Z</dcterms:created>
  <dcterms:modified xsi:type="dcterms:W3CDTF">2023-04-03T20:40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ntentTypeId">
    <vt:lpwstr>0x01010065C5E54B9FF51A4EAFCDF056C7025638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0</vt:i4>
  </property>
  <property fmtid="{D5CDD505-2E9C-101B-9397-08002B2CF9AE}" pid="9" name="PresentationFormat">
    <vt:lpwstr>Breitbild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8</vt:i4>
  </property>
</Properties>
</file>